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109" d="100"/>
          <a:sy n="109" d="100"/>
        </p:scale>
        <p:origin x="-9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252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3870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021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59788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7441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2969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7251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59069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749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0518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8550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6350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oncomintan dru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71662" y="2286000"/>
            <a:ext cx="5400675" cy="457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正方形/長方形 3"/>
          <p:cNvSpPr/>
          <p:nvPr/>
        </p:nvSpPr>
        <p:spPr>
          <a:xfrm>
            <a:off x="944218" y="344556"/>
            <a:ext cx="7200000" cy="17640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dditional file </a:t>
            </a:r>
            <a:r>
              <a:rPr lang="en-US" altLang="ja-JP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ultiple comparison of delta AUC between five groups classified according to concomitant drug usage (all patients).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9952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1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CU</dc:creator>
  <cp:lastModifiedBy>Balindan, Danica Joy</cp:lastModifiedBy>
  <cp:revision>3</cp:revision>
  <dcterms:created xsi:type="dcterms:W3CDTF">2017-01-05T06:51:16Z</dcterms:created>
  <dcterms:modified xsi:type="dcterms:W3CDTF">2017-06-19T14:45:33Z</dcterms:modified>
</cp:coreProperties>
</file>